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33"/>
  </p:normalViewPr>
  <p:slideViewPr>
    <p:cSldViewPr snapToGrid="0">
      <p:cViewPr varScale="1">
        <p:scale>
          <a:sx n="73" d="100"/>
          <a:sy n="73" d="100"/>
        </p:scale>
        <p:origin x="77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0469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726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73899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9774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4733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883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554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2275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897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90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0722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D1253-0CFA-4BC7-8C86-91608C4B1F65}" type="datetimeFigureOut">
              <a:rPr lang="en-GB" smtClean="0"/>
              <a:t>07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B5B09-0C18-4A22-8918-0FDF332A82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543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7345" y="1055187"/>
            <a:ext cx="3701491" cy="264810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37391" y="105507"/>
            <a:ext cx="1019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5230" y="967181"/>
            <a:ext cx="4965192" cy="576072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47345" y="967181"/>
            <a:ext cx="4659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055342" y="967181"/>
            <a:ext cx="55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055342" y="4917858"/>
            <a:ext cx="5597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6632476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1536" y="326722"/>
            <a:ext cx="8948928" cy="632764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37392" y="211015"/>
            <a:ext cx="1019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</a:t>
            </a:r>
          </a:p>
        </p:txBody>
      </p:sp>
    </p:spTree>
    <p:extLst>
      <p:ext uri="{BB962C8B-B14F-4D97-AF65-F5344CB8AC3E}">
        <p14:creationId xmlns:p14="http://schemas.microsoft.com/office/powerpoint/2010/main" val="892812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7392" y="211015"/>
            <a:ext cx="10199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1069" y="1525830"/>
            <a:ext cx="3236976" cy="30723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31982" y="2450700"/>
            <a:ext cx="923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PLAP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59423" y="3524457"/>
            <a:ext cx="11957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yntenin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1618863" y="1485299"/>
            <a:ext cx="23631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 rot="16200000">
            <a:off x="1157268" y="702752"/>
            <a:ext cx="113420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Placental Lysate</a:t>
            </a:r>
          </a:p>
        </p:txBody>
      </p:sp>
      <p:cxnSp>
        <p:nvCxnSpPr>
          <p:cNvPr id="9" name="Straight Connector 8"/>
          <p:cNvCxnSpPr/>
          <p:nvPr/>
        </p:nvCxnSpPr>
        <p:spPr>
          <a:xfrm>
            <a:off x="1987023" y="1494091"/>
            <a:ext cx="29018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2404307" y="1494091"/>
            <a:ext cx="255678" cy="426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2763178" y="1494091"/>
            <a:ext cx="278885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139557" y="1494091"/>
            <a:ext cx="307728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3578469" y="1494091"/>
            <a:ext cx="3029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360985" y="1494091"/>
            <a:ext cx="311739" cy="601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977053" y="1494091"/>
            <a:ext cx="302944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 rot="16200000">
            <a:off x="1458474" y="600226"/>
            <a:ext cx="137979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EDIUM/LARGE STB-EV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1840906" y="688711"/>
            <a:ext cx="13797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MALL STB-EV</a:t>
            </a:r>
          </a:p>
        </p:txBody>
      </p:sp>
      <p:sp>
        <p:nvSpPr>
          <p:cNvPr id="36" name="TextBox 35"/>
          <p:cNvSpPr txBox="1"/>
          <p:nvPr/>
        </p:nvSpPr>
        <p:spPr>
          <a:xfrm rot="16200000">
            <a:off x="2212724" y="628185"/>
            <a:ext cx="13797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MDA-MB-231 SMALL EV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2615232" y="628185"/>
            <a:ext cx="13797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EAHY923 </a:t>
            </a:r>
          </a:p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MALL EV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3059596" y="628185"/>
            <a:ext cx="13797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HUVEC </a:t>
            </a:r>
          </a:p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MALL EV</a:t>
            </a:r>
          </a:p>
        </p:txBody>
      </p:sp>
      <p:sp>
        <p:nvSpPr>
          <p:cNvPr id="39" name="TextBox 38"/>
          <p:cNvSpPr txBox="1"/>
          <p:nvPr/>
        </p:nvSpPr>
        <p:spPr>
          <a:xfrm rot="16200000">
            <a:off x="3459998" y="628185"/>
            <a:ext cx="137979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HEK293T </a:t>
            </a:r>
          </a:p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SMALL EV</a:t>
            </a:r>
          </a:p>
        </p:txBody>
      </p:sp>
      <p:sp>
        <p:nvSpPr>
          <p:cNvPr id="40" name="TextBox 39"/>
          <p:cNvSpPr txBox="1"/>
          <p:nvPr/>
        </p:nvSpPr>
        <p:spPr>
          <a:xfrm rot="16200000">
            <a:off x="3833184" y="708976"/>
            <a:ext cx="137979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Arial" panose="020B0604020202020204" pitchFamily="34" charset="0"/>
                <a:cs typeface="Arial" panose="020B0604020202020204" pitchFamily="34" charset="0"/>
              </a:rPr>
              <a:t>HepG2 Cells</a:t>
            </a:r>
          </a:p>
        </p:txBody>
      </p:sp>
    </p:spTree>
    <p:extLst>
      <p:ext uri="{BB962C8B-B14F-4D97-AF65-F5344CB8AC3E}">
        <p14:creationId xmlns:p14="http://schemas.microsoft.com/office/powerpoint/2010/main" val="1826279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Widescreen</PresentationFormat>
  <Paragraphs>1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19-05-07T16:05:45Z</dcterms:created>
  <dcterms:modified xsi:type="dcterms:W3CDTF">2019-05-07T16:05:58Z</dcterms:modified>
</cp:coreProperties>
</file>